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D5EBA0-7E00-44A2-85C6-226FA8A64C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F36EB57-7C2D-4274-87ED-7CC99B01D9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FAF5E8-C27B-4A50-ABEF-8FD5E6063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E33241-268F-4AF8-89C4-8104C368E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EC5D18-D5E9-47C6-B8BA-1A55CC3BD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593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ED14AD6-173C-492A-9B2E-955AEE38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0C3F39F-C631-4B28-96F6-39A4A8446E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D26D43-9E59-4A7C-A067-720692A2F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7E2F3C-8F2A-4799-9CED-318432A9C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F2A87A-010A-4B05-B6B5-6A4A0FB05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3227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681E8EA-ED52-4311-9277-F0CF815E933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8DC11D8-04F1-4C42-8A93-F0CC2F713D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EC58A0-AE44-44C5-8EE5-9DF07D7FF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26E638-C561-4237-B7F5-13262DFE8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793180-85E6-4B7F-B874-FD8851DE5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2384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923092-493A-4175-AF40-FA69F3494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D7F13A-C2F2-43E9-8A1B-7001C53ACD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C0BDD4-62DD-460D-84BC-FCDC58ADC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267FA4-B486-43B5-A569-84A2A868D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F7CF3D-68CC-453C-91C6-925AA3AFF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6746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A1AAF1-38F6-4354-B2D4-4A49C2B669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4EB0B7-AA53-4FA5-9880-2A2ABC066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9C9830-BF2A-4FCB-9305-91F92A576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AD29C8-7BD5-47D3-B253-1D61CBC46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B5B483-2B95-45FB-A566-895055BA3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992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CB2AF6-540A-42C2-B44F-8C22DA9F0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1AC473B-1C2D-4140-B2EC-F330943A78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89DEB9-FE8D-4CCF-B58D-3FE4F285A8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F5460AE-7179-4635-9E53-6018C7296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07C9D07-27A7-4AA1-8EAC-0463A733F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586F63-CAAB-4666-AF54-175C229E8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0381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9689A3-B3A4-469D-BF6D-C72D17FAD1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8BBA15-E8A4-46C7-8F8E-EF5845110F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D72EB96-AE6D-4E1D-93A7-63E66D9952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62F9C97-6E53-4D68-B44D-C64C746027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1CFD8D2-5386-415D-B4B7-F0A1B88A96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3FEF924-E91C-4733-87BA-F578A30D8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28C67BE-9112-4FBF-B5F8-9197A6FF7B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C25106D-FD9A-4FC8-841B-E902CC5A6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3318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4555A5-146F-4F6C-B6B2-C844CF50C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49EDE85-5F13-43AF-966B-BBAB31DB3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B185766-F4FF-4058-8C6E-DEF5E1EEF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9CADF9F-902A-4A0E-8BBE-F972E41B1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0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5790B9D-F60B-409D-95B6-E54D8B500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AA9BC1C-6636-4A44-AFB5-D268BA188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85C5FC4-6408-43FD-9DC3-E289C0E14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7143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F059F2-2A01-487F-8FE5-D271F0A249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5F345ED-AB2C-4523-BA96-9C12101CC8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8B52B22-935A-4F88-8EB1-3D5EB29603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932748-FE61-4042-BB6F-69EE7E0C3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261A107-8133-4ABA-9378-92703DA28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73AACF-9F99-4AA4-AB52-BADF45FB2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3801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DDDB1F-C027-48CB-8A9B-1A3CDE61F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DC183CE-D4E4-45F8-ABFD-482B9F4A8A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CECD0A6-736B-4E46-B8BE-5C906815A6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ED378BA-0D3D-4CDA-B88F-121030991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C7C3A03-00D6-4063-ADC1-72CF32946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C50E36-4831-4116-8DDF-42FE9FC10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0074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97F7B08-C331-4EA9-A1BE-EA575248F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218F376-8971-4954-991F-D7C3B7CCB1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F01545-F266-4EB2-B90F-9D7341ABDF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40669-6241-4C23-9381-E9127BBFC4A7}" type="datetimeFigureOut">
              <a:rPr lang="zh-CN" altLang="en-US" smtClean="0"/>
              <a:t>2020/3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3D9DD6-B13E-4BD0-A662-94AA811069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8718E0-7E78-4CC4-8151-5B6935AE99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1095B-42D9-4BCB-AD59-8794890C10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8989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picture containing flying, outdoor, airplane, plane&#10;&#10;Description automatically generated">
            <a:extLst>
              <a:ext uri="{FF2B5EF4-FFF2-40B4-BE49-F238E27FC236}">
                <a16:creationId xmlns:a16="http://schemas.microsoft.com/office/drawing/2014/main" id="{6A7F3E11-F623-426F-ADF5-87D258AE16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520" y="-160256"/>
            <a:ext cx="9181403" cy="685800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211E6FFB-D098-4D22-9AA3-A0FA93D6E774}"/>
              </a:ext>
            </a:extLst>
          </p:cNvPr>
          <p:cNvSpPr/>
          <p:nvPr/>
        </p:nvSpPr>
        <p:spPr>
          <a:xfrm>
            <a:off x="4374037" y="3846136"/>
            <a:ext cx="829559" cy="6221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F88A07-BE07-4E73-968A-3B24619AB6AA}"/>
              </a:ext>
            </a:extLst>
          </p:cNvPr>
          <p:cNvSpPr txBox="1"/>
          <p:nvPr/>
        </p:nvSpPr>
        <p:spPr>
          <a:xfrm>
            <a:off x="9662474" y="1791093"/>
            <a:ext cx="23095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TGFB1 in para-osteosarcoma and osteosarcoma</a:t>
            </a:r>
          </a:p>
        </p:txBody>
      </p:sp>
    </p:spTree>
    <p:extLst>
      <p:ext uri="{BB962C8B-B14F-4D97-AF65-F5344CB8AC3E}">
        <p14:creationId xmlns:p14="http://schemas.microsoft.com/office/powerpoint/2010/main" val="1852570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7055F47-12B3-48FE-B36B-9817D30D04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094" y="0"/>
            <a:ext cx="9181403" cy="6858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214FD039-2AFE-4410-88B4-570DEBB7DB1F}"/>
              </a:ext>
            </a:extLst>
          </p:cNvPr>
          <p:cNvSpPr/>
          <p:nvPr/>
        </p:nvSpPr>
        <p:spPr>
          <a:xfrm>
            <a:off x="6570483" y="4826524"/>
            <a:ext cx="763571" cy="3676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6F910C0-CA03-4C34-985B-FFC438E0437E}"/>
              </a:ext>
            </a:extLst>
          </p:cNvPr>
          <p:cNvSpPr txBox="1"/>
          <p:nvPr/>
        </p:nvSpPr>
        <p:spPr>
          <a:xfrm>
            <a:off x="9574339" y="4685122"/>
            <a:ext cx="23095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IGF1 in para-osteosarcoma and osteosarcoma</a:t>
            </a:r>
          </a:p>
        </p:txBody>
      </p:sp>
    </p:spTree>
    <p:extLst>
      <p:ext uri="{BB962C8B-B14F-4D97-AF65-F5344CB8AC3E}">
        <p14:creationId xmlns:p14="http://schemas.microsoft.com/office/powerpoint/2010/main" val="21487837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8BC84F5-0C54-43AA-84F9-CB9F3465D6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5298" y="0"/>
            <a:ext cx="9181403" cy="6858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ED78CC2-1925-4DD2-81B3-31EB167828F1}"/>
              </a:ext>
            </a:extLst>
          </p:cNvPr>
          <p:cNvSpPr/>
          <p:nvPr/>
        </p:nvSpPr>
        <p:spPr>
          <a:xfrm>
            <a:off x="4713402" y="4854805"/>
            <a:ext cx="810705" cy="3676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157BB53-C518-408D-9359-81C42BCC3B74}"/>
              </a:ext>
            </a:extLst>
          </p:cNvPr>
          <p:cNvSpPr txBox="1"/>
          <p:nvPr/>
        </p:nvSpPr>
        <p:spPr>
          <a:xfrm>
            <a:off x="9574339" y="4685122"/>
            <a:ext cx="23095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GAPDH in para-osteosarcoma and osteosarcoma</a:t>
            </a:r>
          </a:p>
        </p:txBody>
      </p:sp>
    </p:spTree>
    <p:extLst>
      <p:ext uri="{BB962C8B-B14F-4D97-AF65-F5344CB8AC3E}">
        <p14:creationId xmlns:p14="http://schemas.microsoft.com/office/powerpoint/2010/main" val="12142918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597E2FA-3432-4FC8-B055-F8E6CF513B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5298" y="0"/>
            <a:ext cx="9181403" cy="6858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2323692-8657-4585-9F53-E76CF5803FED}"/>
              </a:ext>
            </a:extLst>
          </p:cNvPr>
          <p:cNvSpPr/>
          <p:nvPr/>
        </p:nvSpPr>
        <p:spPr>
          <a:xfrm>
            <a:off x="4430598" y="2771481"/>
            <a:ext cx="810705" cy="3676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D95050-1665-4529-8CF0-C11B27413C73}"/>
              </a:ext>
            </a:extLst>
          </p:cNvPr>
          <p:cNvSpPr txBox="1"/>
          <p:nvPr/>
        </p:nvSpPr>
        <p:spPr>
          <a:xfrm>
            <a:off x="1505298" y="2228671"/>
            <a:ext cx="23095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IL10 in para-osteosarcoma and osteosarcoma</a:t>
            </a:r>
          </a:p>
        </p:txBody>
      </p:sp>
    </p:spTree>
    <p:extLst>
      <p:ext uri="{BB962C8B-B14F-4D97-AF65-F5344CB8AC3E}">
        <p14:creationId xmlns:p14="http://schemas.microsoft.com/office/powerpoint/2010/main" val="28367152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9">
            <a:extLst>
              <a:ext uri="{FF2B5EF4-FFF2-40B4-BE49-F238E27FC236}">
                <a16:creationId xmlns:a16="http://schemas.microsoft.com/office/drawing/2014/main" id="{E814189C-9191-42EB-AA43-97DAF2E9558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04" t="16516" r="16958" b="42158"/>
          <a:stretch/>
        </p:blipFill>
        <p:spPr>
          <a:xfrm>
            <a:off x="758857" y="141402"/>
            <a:ext cx="10674285" cy="63065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0C8D0B85-90B3-492E-BF7A-122058DAF0D4}"/>
              </a:ext>
            </a:extLst>
          </p:cNvPr>
          <p:cNvSpPr/>
          <p:nvPr/>
        </p:nvSpPr>
        <p:spPr>
          <a:xfrm>
            <a:off x="2253006" y="3723588"/>
            <a:ext cx="1923068" cy="7447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5223D50-F6B5-4207-9255-1A7D8FE0B90E}"/>
              </a:ext>
            </a:extLst>
          </p:cNvPr>
          <p:cNvSpPr txBox="1"/>
          <p:nvPr/>
        </p:nvSpPr>
        <p:spPr>
          <a:xfrm>
            <a:off x="-464904" y="3723588"/>
            <a:ext cx="230956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VEGFA in para-osteosarcoma and osteosarcoma</a:t>
            </a:r>
          </a:p>
        </p:txBody>
      </p:sp>
    </p:spTree>
    <p:extLst>
      <p:ext uri="{BB962C8B-B14F-4D97-AF65-F5344CB8AC3E}">
        <p14:creationId xmlns:p14="http://schemas.microsoft.com/office/powerpoint/2010/main" val="2971363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10">
            <a:extLst>
              <a:ext uri="{FF2B5EF4-FFF2-40B4-BE49-F238E27FC236}">
                <a16:creationId xmlns:a16="http://schemas.microsoft.com/office/drawing/2014/main" id="{0F178342-06E7-4737-916F-9D4501C5FE7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4314" t="32451" r="15193" b="22273"/>
          <a:stretch/>
        </p:blipFill>
        <p:spPr>
          <a:xfrm>
            <a:off x="861351" y="1118681"/>
            <a:ext cx="9144000" cy="43860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1880E58-B4C8-482F-B7BD-F7E3E178DDFC}"/>
              </a:ext>
            </a:extLst>
          </p:cNvPr>
          <p:cNvSpPr/>
          <p:nvPr/>
        </p:nvSpPr>
        <p:spPr>
          <a:xfrm>
            <a:off x="4464995" y="2937753"/>
            <a:ext cx="968355" cy="4912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6382150-B068-463A-BC82-29B35AE7350D}"/>
              </a:ext>
            </a:extLst>
          </p:cNvPr>
          <p:cNvSpPr txBox="1"/>
          <p:nvPr/>
        </p:nvSpPr>
        <p:spPr>
          <a:xfrm>
            <a:off x="353606" y="2831633"/>
            <a:ext cx="23095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IL10 in EPO- and EPO+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115819A-9522-4EE6-BC0D-17AA31615C38}"/>
              </a:ext>
            </a:extLst>
          </p:cNvPr>
          <p:cNvSpPr/>
          <p:nvPr/>
        </p:nvSpPr>
        <p:spPr>
          <a:xfrm>
            <a:off x="4464995" y="3477964"/>
            <a:ext cx="968355" cy="4912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DE72E66-BA88-44F7-AFEA-806224D93BB6}"/>
              </a:ext>
            </a:extLst>
          </p:cNvPr>
          <p:cNvSpPr txBox="1"/>
          <p:nvPr/>
        </p:nvSpPr>
        <p:spPr>
          <a:xfrm>
            <a:off x="270336" y="3521826"/>
            <a:ext cx="23095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TGFB1 in EPO- and EPO+</a:t>
            </a:r>
          </a:p>
        </p:txBody>
      </p:sp>
    </p:spTree>
    <p:extLst>
      <p:ext uri="{BB962C8B-B14F-4D97-AF65-F5344CB8AC3E}">
        <p14:creationId xmlns:p14="http://schemas.microsoft.com/office/powerpoint/2010/main" val="11944859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9">
            <a:extLst>
              <a:ext uri="{FF2B5EF4-FFF2-40B4-BE49-F238E27FC236}">
                <a16:creationId xmlns:a16="http://schemas.microsoft.com/office/drawing/2014/main" id="{2A454EF6-36BC-4133-A89D-A6E8C34E3B1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237" t="35279" r="38950" b="13852"/>
          <a:stretch/>
        </p:blipFill>
        <p:spPr>
          <a:xfrm>
            <a:off x="1376313" y="329938"/>
            <a:ext cx="7315200" cy="59819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66E57AE-B566-45E4-96FE-375D91D07B20}"/>
              </a:ext>
            </a:extLst>
          </p:cNvPr>
          <p:cNvSpPr/>
          <p:nvPr/>
        </p:nvSpPr>
        <p:spPr>
          <a:xfrm>
            <a:off x="4312762" y="2928326"/>
            <a:ext cx="1442301" cy="6067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787400F-8EFA-4F29-90B7-12C0DE5B6334}"/>
              </a:ext>
            </a:extLst>
          </p:cNvPr>
          <p:cNvSpPr txBox="1"/>
          <p:nvPr/>
        </p:nvSpPr>
        <p:spPr>
          <a:xfrm>
            <a:off x="136790" y="2770023"/>
            <a:ext cx="23095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VEGFA in EPO- and EPO+</a:t>
            </a:r>
          </a:p>
        </p:txBody>
      </p:sp>
    </p:spTree>
    <p:extLst>
      <p:ext uri="{BB962C8B-B14F-4D97-AF65-F5344CB8AC3E}">
        <p14:creationId xmlns:p14="http://schemas.microsoft.com/office/powerpoint/2010/main" val="9618998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2">
            <a:extLst>
              <a:ext uri="{FF2B5EF4-FFF2-40B4-BE49-F238E27FC236}">
                <a16:creationId xmlns:a16="http://schemas.microsoft.com/office/drawing/2014/main" id="{95AAD8E9-63C6-4C6B-B0D3-F2994DF6AB5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005" t="39265" r="30359" b="34125"/>
          <a:stretch/>
        </p:blipFill>
        <p:spPr>
          <a:xfrm>
            <a:off x="1866206" y="1649691"/>
            <a:ext cx="7532318" cy="43551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1C177CB8-BDF9-4E19-9949-833728F79A96}"/>
              </a:ext>
            </a:extLst>
          </p:cNvPr>
          <p:cNvSpPr/>
          <p:nvPr/>
        </p:nvSpPr>
        <p:spPr>
          <a:xfrm>
            <a:off x="4213782" y="2928326"/>
            <a:ext cx="1734532" cy="691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D9ED2BE-5246-4270-A4DB-1EA80579A557}"/>
              </a:ext>
            </a:extLst>
          </p:cNvPr>
          <p:cNvSpPr txBox="1"/>
          <p:nvPr/>
        </p:nvSpPr>
        <p:spPr>
          <a:xfrm>
            <a:off x="136790" y="2770023"/>
            <a:ext cx="23095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IGF1 in EPO- and EPO+</a:t>
            </a:r>
          </a:p>
        </p:txBody>
      </p:sp>
    </p:spTree>
    <p:extLst>
      <p:ext uri="{BB962C8B-B14F-4D97-AF65-F5344CB8AC3E}">
        <p14:creationId xmlns:p14="http://schemas.microsoft.com/office/powerpoint/2010/main" val="548765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8">
            <a:extLst>
              <a:ext uri="{FF2B5EF4-FFF2-40B4-BE49-F238E27FC236}">
                <a16:creationId xmlns:a16="http://schemas.microsoft.com/office/drawing/2014/main" id="{D5898150-410D-49A5-9F19-FF8E5E1A3F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64" t="31929" r="53426" b="34921"/>
          <a:stretch/>
        </p:blipFill>
        <p:spPr>
          <a:xfrm>
            <a:off x="179109" y="810705"/>
            <a:ext cx="8248454" cy="51847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7960B03-8FD4-4298-9AB0-DB1253D8B862}"/>
              </a:ext>
            </a:extLst>
          </p:cNvPr>
          <p:cNvSpPr/>
          <p:nvPr/>
        </p:nvSpPr>
        <p:spPr>
          <a:xfrm>
            <a:off x="3827283" y="2918900"/>
            <a:ext cx="1734532" cy="691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7EA259-0F46-4BD2-A2D5-D548D43F722B}"/>
              </a:ext>
            </a:extLst>
          </p:cNvPr>
          <p:cNvSpPr txBox="1"/>
          <p:nvPr/>
        </p:nvSpPr>
        <p:spPr>
          <a:xfrm>
            <a:off x="136790" y="2770023"/>
            <a:ext cx="23095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he raw data of GAPDH in EPO- and EPO+</a:t>
            </a:r>
          </a:p>
        </p:txBody>
      </p:sp>
    </p:spTree>
    <p:extLst>
      <p:ext uri="{BB962C8B-B14F-4D97-AF65-F5344CB8AC3E}">
        <p14:creationId xmlns:p14="http://schemas.microsoft.com/office/powerpoint/2010/main" val="3395099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95</Words>
  <Application>Microsoft Office PowerPoint</Application>
  <PresentationFormat>Widescreen</PresentationFormat>
  <Paragraphs>1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ryvivid</dc:creator>
  <cp:lastModifiedBy>li wei</cp:lastModifiedBy>
  <cp:revision>19</cp:revision>
  <dcterms:created xsi:type="dcterms:W3CDTF">2019-08-15T17:17:05Z</dcterms:created>
  <dcterms:modified xsi:type="dcterms:W3CDTF">2020-03-18T08:23:15Z</dcterms:modified>
</cp:coreProperties>
</file>